
<file path=[Content_Types].xml><?xml version="1.0" encoding="utf-8"?>
<Types xmlns="http://schemas.openxmlformats.org/package/2006/content-types">
  <Default Extension="gif" ContentType="image/gif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1915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schler, L. (RADI)" initials="HL(" lastIdx="18" clrIdx="0">
    <p:extLst>
      <p:ext uri="{19B8F6BF-5375-455C-9EA6-DF929625EA0E}">
        <p15:presenceInfo xmlns:p15="http://schemas.microsoft.com/office/powerpoint/2012/main" userId="S::L.Hirschler@lumc.nl::1b88d5c6-10ed-43ec-86cf-97c638b76051" providerId="AD"/>
      </p:ext>
    </p:extLst>
  </p:cmAuthor>
  <p:cmAuthor id="2" name="Runderkamp, B.A. (Bobby)" initials="RB(" lastIdx="18" clrIdx="1">
    <p:extLst>
      <p:ext uri="{19B8F6BF-5375-455C-9EA6-DF929625EA0E}">
        <p15:presenceInfo xmlns:p15="http://schemas.microsoft.com/office/powerpoint/2012/main" userId="S-1-5-21-2169066342-2480738168-2466311071-21457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48" autoAdjust="0"/>
    <p:restoredTop sz="87317" autoAdjust="0"/>
  </p:normalViewPr>
  <p:slideViewPr>
    <p:cSldViewPr snapToGrid="0">
      <p:cViewPr varScale="1">
        <p:scale>
          <a:sx n="108" d="100"/>
          <a:sy n="108" d="100"/>
        </p:scale>
        <p:origin x="76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75169F-19AC-4CFD-BBCD-31A5DCB63DEF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A0AE03-9158-44FE-9B4F-0A0930D7BA0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56493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B9CE5-91B9-4884-82C5-E473886898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24AC1B-6D86-4BD1-A61C-726DB70E76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7CB56C-4A48-4941-99BE-A42395FA9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94C0DF-EB6B-4AE8-B508-38F4C6C35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0B90CF-07CA-48C2-883B-8CDB8B352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1000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244F34-DB4E-4A93-9787-36FFE819BF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6E017A-EFEE-40B5-A7B4-8FEE855A69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EF17FD-8163-4671-8556-49C846883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9EF512-1521-419C-9AC4-615379D1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B1023D-C821-4159-9BFC-CFC912734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9120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96E50D-E514-46CF-8031-595C4254BF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2F15A9-C26C-4DD1-BF8E-7B3B8AC0A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7A5944-B2B3-4ADA-B1F7-953681A60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00712-501A-41B4-AE87-EBA5ADC47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48F04B-7B2F-48AE-A5E5-36A61AC05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16132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DD1F6C-2D30-463E-8B6A-CF9D40B78D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0055B6-263F-49BC-9995-9DC2FD873E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F7A30A-0585-4B57-A8B3-FBECF5622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54B9D3-0B45-496E-9DA3-63AEF748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E1E66-29B1-47CF-8C3F-A2380C557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67512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401261-771A-4EFF-A2A7-F68A6AF72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A47822-2BEA-4C08-BB7B-97084E5250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390361-740A-4DF3-8724-93D8328FB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40A2C3-EC5B-4046-98EE-AE36A0D6D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228225-5EC9-46BB-B2BD-EEE7F53A7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56193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7D8BB-D05B-4C52-9A1F-42F0AD1C29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486870-A2B4-4D8E-99DB-02D65E3CBA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64C14B-5AA6-41B5-A0A9-1495C0582C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931D59-22F4-43C1-A552-7265C1F48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F29FEF-EA42-45B3-8927-0AAE8CAAF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014341-C6FA-4234-97CC-89946B3B4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8701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7C10DB-9FEB-43FA-8EFB-B0938B7C10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707C9E-3095-428C-81D3-D5CDE8BEC8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294017-3EA8-4CC8-B93D-D8E79354D0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4561F6-C694-450A-8FC8-C0D1035AD0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91891D-12F9-45D9-8C2F-EB92E23FE1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C03131-A08D-437D-B905-7E7F766CD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6CE958-A0C9-4885-A7A6-D1D5D0EB1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F7DAB9-026F-4DE4-ABFE-94A6832B9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15544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7B1F7-B7DD-43A6-AD0B-17516BBF1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E412A7-8F18-42C2-B40C-D66127824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E34165-7332-4BA5-8F5E-F90F6A62A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A20AD9-A21B-41CD-88D8-FF00BF332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31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AA90EC-1C5F-4CC9-B93A-B3A9A10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11E0D1-FC05-4153-80EF-02AF377B0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D079F2-C238-4125-8FD4-3E34D629C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36707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6E5A21-E44D-441C-9A5B-472549669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08681E-4E53-47FC-87F7-272BA9A63B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9756DA-A499-40E6-BC9E-3ECDA0877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E4D5A1-1428-4A44-B7A4-4971AD017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8C2404-FF21-4645-A2C2-9E0676464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D781E0-C306-4D93-AC5A-C7E1CF70F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43007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27D8D-F014-4AD7-B50D-81F327594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87CDB4B-BE9A-40D2-ABB5-943CD54833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BB220D-E4FC-485D-B269-BBE5042DC0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18C76B-C51E-4A5E-810A-004D4BFBA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807F75-9B0D-440B-9084-FC10A0759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17F733-35EE-40CA-8F6B-7DF1F9A5E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520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AD07AB-F973-4ECC-A3DF-56D1D3B2A4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7F82BE-5E12-4CBE-BCFE-FFF4B013BA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C4AA66-B5A3-47DD-9F43-8D09CCE237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FCCC2-B69D-4639-8812-3591BD3D0F73}" type="datetimeFigureOut">
              <a:rPr lang="nl-NL" smtClean="0"/>
              <a:t>08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0576A-033B-400D-93DC-E089C31EEA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BFDFA-8A73-493D-B2FB-1376E23D99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081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gif"/><Relationship Id="rId5" Type="http://schemas.openxmlformats.org/officeDocument/2006/relationships/image" Target="../media/image4.png"/><Relationship Id="rId10" Type="http://schemas.openxmlformats.org/officeDocument/2006/relationships/image" Target="../media/image9.gif"/><Relationship Id="rId4" Type="http://schemas.openxmlformats.org/officeDocument/2006/relationships/image" Target="../media/image3.png"/><Relationship Id="rId9" Type="http://schemas.openxmlformats.org/officeDocument/2006/relationships/image" Target="../media/image8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9EEBF332-3624-43DE-9C28-837A8BBA0F90}"/>
              </a:ext>
            </a:extLst>
          </p:cNvPr>
          <p:cNvSpPr/>
          <p:nvPr/>
        </p:nvSpPr>
        <p:spPr bwMode="auto">
          <a:xfrm>
            <a:off x="1" y="1533525"/>
            <a:ext cx="12191999" cy="4816475"/>
          </a:xfrm>
          <a:prstGeom prst="rect">
            <a:avLst/>
          </a:prstGeom>
          <a:solidFill>
            <a:srgbClr val="000000"/>
          </a:solidFill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nl-NL" sz="2400" b="0" i="0" u="none" strike="noStrike" kern="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" charset="0"/>
              <a:ea typeface="ＭＳ Ｐゴシック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80854414-BC26-4A95-B5CF-08DCBBAB35B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16"/>
          <a:stretch/>
        </p:blipFill>
        <p:spPr>
          <a:xfrm>
            <a:off x="2732954" y="5524500"/>
            <a:ext cx="8992319" cy="191050"/>
          </a:xfrm>
          <a:prstGeom prst="rect">
            <a:avLst/>
          </a:prstGeom>
        </p:spPr>
      </p:pic>
      <p:grpSp>
        <p:nvGrpSpPr>
          <p:cNvPr id="29" name="Group 28">
            <a:extLst>
              <a:ext uri="{FF2B5EF4-FFF2-40B4-BE49-F238E27FC236}">
                <a16:creationId xmlns:a16="http://schemas.microsoft.com/office/drawing/2014/main" id="{189C3D61-8996-4E22-AB78-CC8F7398D84F}"/>
              </a:ext>
            </a:extLst>
          </p:cNvPr>
          <p:cNvGrpSpPr/>
          <p:nvPr/>
        </p:nvGrpSpPr>
        <p:grpSpPr>
          <a:xfrm>
            <a:off x="2549060" y="5711893"/>
            <a:ext cx="9423896" cy="300082"/>
            <a:chOff x="7228094" y="6181793"/>
            <a:chExt cx="3686105" cy="300082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99596E9-0A1C-4589-920E-67AE91C2FEE0}"/>
                </a:ext>
              </a:extLst>
            </p:cNvPr>
            <p:cNvSpPr txBox="1"/>
            <p:nvPr/>
          </p:nvSpPr>
          <p:spPr>
            <a:xfrm>
              <a:off x="7228094" y="6181793"/>
              <a:ext cx="309788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50" b="0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</a:rPr>
                <a:t>-10</a:t>
              </a:r>
              <a:endParaRPr kumimoji="0" lang="nl-NL" sz="135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D7E36F2-5106-4E73-9F0B-E9FC09F4891B}"/>
                </a:ext>
              </a:extLst>
            </p:cNvPr>
            <p:cNvSpPr txBox="1"/>
            <p:nvPr/>
          </p:nvSpPr>
          <p:spPr>
            <a:xfrm>
              <a:off x="10738341" y="6181793"/>
              <a:ext cx="175858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50" b="0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</a:rPr>
                <a:t>10</a:t>
              </a:r>
              <a:endParaRPr kumimoji="0" lang="nl-NL" sz="135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538753D-FC74-4421-BE43-9CDE2B8D56A8}"/>
                </a:ext>
              </a:extLst>
            </p:cNvPr>
            <p:cNvSpPr txBox="1"/>
            <p:nvPr/>
          </p:nvSpPr>
          <p:spPr>
            <a:xfrm>
              <a:off x="7341288" y="6181793"/>
              <a:ext cx="347603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50" b="0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</a:rPr>
                <a:t>CSF-mobility change (%)</a:t>
              </a:r>
              <a:endParaRPr kumimoji="0" lang="nl-NL" sz="135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34" name="Title 1">
            <a:extLst>
              <a:ext uri="{FF2B5EF4-FFF2-40B4-BE49-F238E27FC236}">
                <a16:creationId xmlns:a16="http://schemas.microsoft.com/office/drawing/2014/main" id="{CAF0C9F8-7C91-4307-924C-F9BF1FEA6886}"/>
              </a:ext>
            </a:extLst>
          </p:cNvPr>
          <p:cNvSpPr txBox="1">
            <a:spLocks/>
          </p:cNvSpPr>
          <p:nvPr/>
        </p:nvSpPr>
        <p:spPr>
          <a:xfrm>
            <a:off x="459451" y="-118737"/>
            <a:ext cx="1126582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</a:rPr>
              <a:t>Suppl. video </a:t>
            </a:r>
            <a:r>
              <a:rPr lang="ie-Latn-001" sz="1800" b="1" dirty="0">
                <a:latin typeface="Calibri" panose="020F0502020204030204" pitchFamily="34" charset="0"/>
              </a:rPr>
              <a:t>3</a:t>
            </a:r>
            <a:r>
              <a:rPr lang="en-US" sz="1800" b="1" dirty="0">
                <a:latin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imation of </a:t>
            </a:r>
            <a:r>
              <a:rPr lang="en-US" sz="1800" b="1" dirty="0">
                <a:latin typeface="Calibri" panose="020F0502020204030204" pitchFamily="34" charset="0"/>
                <a:cs typeface="Times New Roman" panose="02020603050405020304" pitchFamily="18" charset="0"/>
              </a:rPr>
              <a:t>CSF-mobility change across driving forces in PVS</a:t>
            </a:r>
            <a:r>
              <a:rPr lang="ie-Latn-001" sz="1800" b="1" dirty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latin typeface="Calibri" panose="020F0502020204030204" pitchFamily="34" charset="0"/>
                <a:cs typeface="Times New Roman" panose="02020603050405020304" pitchFamily="18" charset="0"/>
              </a:rPr>
              <a:t>around penetrating vessels</a:t>
            </a:r>
            <a:endParaRPr lang="en-US" sz="2800" dirty="0">
              <a:latin typeface="+mn-lt"/>
              <a:ea typeface="+mn-ea"/>
              <a:cs typeface="+mn-cs"/>
            </a:endParaRPr>
          </a:p>
        </p:txBody>
      </p:sp>
      <p:pic>
        <p:nvPicPr>
          <p:cNvPr id="38" name="Picture 37" descr="A picture containing dark&#10;&#10;Description automatically generated">
            <a:extLst>
              <a:ext uri="{FF2B5EF4-FFF2-40B4-BE49-F238E27FC236}">
                <a16:creationId xmlns:a16="http://schemas.microsoft.com/office/drawing/2014/main" id="{59F135BF-9734-46EB-9750-13BA4E1310B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75" t="2361" r="25179" b="6868"/>
          <a:stretch/>
        </p:blipFill>
        <p:spPr>
          <a:xfrm>
            <a:off x="158269" y="1952394"/>
            <a:ext cx="2306235" cy="2854624"/>
          </a:xfrm>
          <a:prstGeom prst="rect">
            <a:avLst/>
          </a:prstGeom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id="{AC558F8D-EA18-4A54-9A90-A7FC89C3905F}"/>
              </a:ext>
            </a:extLst>
          </p:cNvPr>
          <p:cNvSpPr/>
          <p:nvPr/>
        </p:nvSpPr>
        <p:spPr>
          <a:xfrm>
            <a:off x="738414" y="4038925"/>
            <a:ext cx="486655" cy="325755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n w="28575">
                <a:solidFill>
                  <a:schemeClr val="tx1"/>
                </a:solidFill>
              </a:ln>
            </a:endParaRPr>
          </a:p>
        </p:txBody>
      </p:sp>
      <p:pic>
        <p:nvPicPr>
          <p:cNvPr id="33" name="Picture 32" descr="Shape&#10;&#10;Description automatically generated">
            <a:extLst>
              <a:ext uri="{FF2B5EF4-FFF2-40B4-BE49-F238E27FC236}">
                <a16:creationId xmlns:a16="http://schemas.microsoft.com/office/drawing/2014/main" id="{7BBA7E74-2AE7-4765-8E70-6746CFEE19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6988" y="2063596"/>
            <a:ext cx="2567307" cy="588575"/>
          </a:xfrm>
          <a:prstGeom prst="rect">
            <a:avLst/>
          </a:prstGeom>
        </p:spPr>
      </p:pic>
      <p:pic>
        <p:nvPicPr>
          <p:cNvPr id="35" name="Picture 34" descr="Icon&#10;&#10;Description automatically generated">
            <a:extLst>
              <a:ext uri="{FF2B5EF4-FFF2-40B4-BE49-F238E27FC236}">
                <a16:creationId xmlns:a16="http://schemas.microsoft.com/office/drawing/2014/main" id="{94BC485E-27D7-458B-A946-30EB5686A42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5475" y="2020927"/>
            <a:ext cx="2718655" cy="667051"/>
          </a:xfrm>
          <a:prstGeom prst="rect">
            <a:avLst/>
          </a:prstGeom>
        </p:spPr>
      </p:pic>
      <p:pic>
        <p:nvPicPr>
          <p:cNvPr id="36" name="Graphic 35" descr="Dice with solid fill">
            <a:extLst>
              <a:ext uri="{FF2B5EF4-FFF2-40B4-BE49-F238E27FC236}">
                <a16:creationId xmlns:a16="http://schemas.microsoft.com/office/drawing/2014/main" id="{A0D17F55-4FFF-4458-BD07-E149B439453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 rot="19486456">
            <a:off x="10004515" y="1809160"/>
            <a:ext cx="1148898" cy="1148898"/>
          </a:xfrm>
          <a:prstGeom prst="rect">
            <a:avLst/>
          </a:prstGeom>
        </p:spPr>
      </p:pic>
      <p:pic>
        <p:nvPicPr>
          <p:cNvPr id="20" name="Picture 19" descr="A picture containing ctenophore, night sky&#10;&#10;Description automatically generated">
            <a:extLst>
              <a:ext uri="{FF2B5EF4-FFF2-40B4-BE49-F238E27FC236}">
                <a16:creationId xmlns:a16="http://schemas.microsoft.com/office/drawing/2014/main" id="{E619D7E0-BB41-4A96-8252-9CEA3F12F23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42" t="29969" r="38394" b="30492"/>
          <a:stretch/>
        </p:blipFill>
        <p:spPr>
          <a:xfrm>
            <a:off x="300360" y="4931683"/>
            <a:ext cx="1364889" cy="1156200"/>
          </a:xfrm>
          <a:prstGeom prst="rect">
            <a:avLst/>
          </a:prstGeom>
        </p:spPr>
      </p:pic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63B31E4-6B84-4A43-B553-FD3FB3820D18}"/>
              </a:ext>
            </a:extLst>
          </p:cNvPr>
          <p:cNvCxnSpPr>
            <a:cxnSpLocks/>
          </p:cNvCxnSpPr>
          <p:nvPr/>
        </p:nvCxnSpPr>
        <p:spPr>
          <a:xfrm flipV="1">
            <a:off x="254697" y="4364682"/>
            <a:ext cx="483717" cy="53158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5627578F-8C7C-40C2-AB45-9C6E1D96CF2B}"/>
              </a:ext>
            </a:extLst>
          </p:cNvPr>
          <p:cNvSpPr/>
          <p:nvPr/>
        </p:nvSpPr>
        <p:spPr>
          <a:xfrm>
            <a:off x="249270" y="4896262"/>
            <a:ext cx="1475265" cy="1227986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n w="28575">
                <a:solidFill>
                  <a:schemeClr val="tx1"/>
                </a:solidFill>
              </a:ln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2BDA4E6-4321-4FF1-B3C6-117192C83AC1}"/>
              </a:ext>
            </a:extLst>
          </p:cNvPr>
          <p:cNvCxnSpPr>
            <a:cxnSpLocks/>
          </p:cNvCxnSpPr>
          <p:nvPr/>
        </p:nvCxnSpPr>
        <p:spPr>
          <a:xfrm flipH="1" flipV="1">
            <a:off x="1225070" y="4364682"/>
            <a:ext cx="499465" cy="53158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D29EFB98-EE83-48C4-84BB-6E341A48DFD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7217" y="2722316"/>
            <a:ext cx="3060152" cy="2375044"/>
          </a:xfrm>
          <a:prstGeom prst="rect">
            <a:avLst/>
          </a:prstGeom>
        </p:spPr>
      </p:pic>
      <p:pic>
        <p:nvPicPr>
          <p:cNvPr id="7" name="Picture 6" descr="A picture containing chart&#10;&#10;Description automatically generated">
            <a:extLst>
              <a:ext uri="{FF2B5EF4-FFF2-40B4-BE49-F238E27FC236}">
                <a16:creationId xmlns:a16="http://schemas.microsoft.com/office/drawing/2014/main" id="{5ACDCB26-5A4F-4AD9-8A7F-EB74EAF1960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2772" y="2722316"/>
            <a:ext cx="3060152" cy="2375044"/>
          </a:xfrm>
          <a:prstGeom prst="rect">
            <a:avLst/>
          </a:prstGeom>
        </p:spPr>
      </p:pic>
      <p:pic>
        <p:nvPicPr>
          <p:cNvPr id="10" name="Picture 9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AD9C022B-AD5A-429E-8AFB-1BAB9C3F909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8888" y="2722316"/>
            <a:ext cx="3060152" cy="237504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288E771-23DC-6DB5-29FD-F5AEC1D7203C}"/>
              </a:ext>
            </a:extLst>
          </p:cNvPr>
          <p:cNvSpPr txBox="1"/>
          <p:nvPr/>
        </p:nvSpPr>
        <p:spPr>
          <a:xfrm>
            <a:off x="459451" y="662541"/>
            <a:ext cx="102929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SF-mobility change from the mean value over phases (in %) across the cardiac (left), respiration (middle) and random (right) cycles in one representative individual (same data as in Fig. 4, but as a gif).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lease note that a linear interpolation was applied between the phases to visually smoothen the video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40234572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795</TotalTime>
  <Words>8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schler, L. (RADI)</dc:creator>
  <cp:lastModifiedBy>Hirschler, L. (RADI)</cp:lastModifiedBy>
  <cp:revision>180</cp:revision>
  <dcterms:created xsi:type="dcterms:W3CDTF">2021-03-24T12:06:00Z</dcterms:created>
  <dcterms:modified xsi:type="dcterms:W3CDTF">2025-07-15T14:56:01Z</dcterms:modified>
</cp:coreProperties>
</file>